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77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383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90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408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68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021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956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135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496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389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63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717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49B76-A3A0-47ED-BFC6-CF448EA6841A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19D52-ADB6-471C-A794-A3F2870DD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77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0422363"/>
              </p:ext>
            </p:extLst>
          </p:nvPr>
        </p:nvGraphicFramePr>
        <p:xfrm>
          <a:off x="1345752" y="1191275"/>
          <a:ext cx="9598649" cy="27432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12860"/>
                <a:gridCol w="3594399"/>
                <a:gridCol w="3991390"/>
              </a:tblGrid>
              <a:tr h="44323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 smtClean="0"/>
                        <a:t>MCF7</a:t>
                      </a:r>
                      <a:endParaRPr lang="en-US" sz="1800" dirty="0" smtClean="0">
                        <a:solidFill>
                          <a:schemeClr val="bg1"/>
                        </a:solidFill>
                      </a:endParaRP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dirty="0" smtClean="0"/>
                        <a:t>Fulvestrant  IC50/</a:t>
                      </a:r>
                      <a:r>
                        <a:rPr lang="en-US" sz="2400" baseline="0" dirty="0" smtClean="0"/>
                        <a:t> pIC50 </a:t>
                      </a:r>
                      <a:endParaRPr lang="en-US" sz="2400" dirty="0" smtClean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AZD9496     IC50/</a:t>
                      </a:r>
                      <a:r>
                        <a:rPr lang="en-US" sz="2400" baseline="0" dirty="0" smtClean="0"/>
                        <a:t> pIC50 </a:t>
                      </a:r>
                      <a:endParaRPr lang="en-US" sz="2400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</a:tr>
              <a:tr h="443238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10% FBS</a:t>
                      </a:r>
                      <a:endParaRPr lang="en-US" sz="2400" dirty="0"/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2400" kern="1200" baseline="0" dirty="0" smtClean="0"/>
                        <a:t>2.251 </a:t>
                      </a:r>
                      <a:r>
                        <a:rPr lang="en-US" sz="2400" kern="1200" baseline="0" dirty="0" smtClean="0"/>
                        <a:t>e-9 </a:t>
                      </a:r>
                      <a:r>
                        <a:rPr lang="en-US" sz="2400" kern="1200" baseline="0" dirty="0" smtClean="0"/>
                        <a:t>/ 8.648</a:t>
                      </a:r>
                      <a:endParaRPr lang="en-US" sz="2400" b="1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946" marR="4946" marT="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kern="1200" baseline="0" dirty="0" smtClean="0"/>
                        <a:t>1.652 </a:t>
                      </a:r>
                      <a:r>
                        <a:rPr lang="en-US" sz="2400" kern="1200" baseline="0" dirty="0" smtClean="0"/>
                        <a:t>e-9 </a:t>
                      </a:r>
                      <a:r>
                        <a:rPr lang="en-US" sz="2400" kern="1200" baseline="0" dirty="0" smtClean="0"/>
                        <a:t>/8.782</a:t>
                      </a:r>
                      <a:endParaRPr lang="en-US" sz="2400" b="1" kern="1200" baseline="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/>
                </a:tc>
              </a:tr>
              <a:tr h="443238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ED + E2 </a:t>
                      </a:r>
                      <a:r>
                        <a:rPr lang="en-US" sz="2400" baseline="30000" dirty="0" smtClean="0"/>
                        <a:t>-9</a:t>
                      </a:r>
                      <a:endParaRPr lang="en-US" sz="2400" baseline="30000" dirty="0"/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9.022</a:t>
                      </a:r>
                      <a:r>
                        <a:rPr lang="en-US" sz="2400" baseline="0" dirty="0" smtClean="0"/>
                        <a:t> e-8 / 7.04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aseline="0" dirty="0" smtClean="0"/>
                        <a:t>7.148 </a:t>
                      </a:r>
                      <a:r>
                        <a:rPr lang="en-US" sz="2400" dirty="0" smtClean="0"/>
                        <a:t>e-8 / 7.15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</a:tr>
              <a:tr h="443238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ED + E2 </a:t>
                      </a:r>
                      <a:r>
                        <a:rPr lang="en-US" sz="2400" baseline="30000" dirty="0" smtClean="0"/>
                        <a:t>-12</a:t>
                      </a:r>
                      <a:endParaRPr lang="en-US" sz="2400" baseline="30000" dirty="0"/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8.532 e-11 / 10.07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1.693 e-10 / 9.77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</a:tr>
              <a:tr h="443238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ED + E2 </a:t>
                      </a:r>
                      <a:r>
                        <a:rPr lang="en-US" sz="2400" baseline="30000" dirty="0" smtClean="0"/>
                        <a:t>-15</a:t>
                      </a:r>
                      <a:endParaRPr lang="en-US" sz="2400" baseline="30000" dirty="0"/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dirty="0" smtClean="0"/>
                        <a:t>6.149 e-11 / 10.21</a:t>
                      </a:r>
                      <a:endParaRPr lang="en-US" sz="2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2.982 e-11 / 10.53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</a:tr>
              <a:tr h="443238">
                <a:tc>
                  <a:txBody>
                    <a:bodyPr/>
                    <a:lstStyle/>
                    <a:p>
                      <a:r>
                        <a:rPr lang="en-US" sz="2400" dirty="0" smtClean="0"/>
                        <a:t>ED</a:t>
                      </a: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5.556</a:t>
                      </a:r>
                      <a:r>
                        <a:rPr lang="en-US" sz="2400" baseline="0" dirty="0" smtClean="0"/>
                        <a:t> e-11 / 10.26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 smtClean="0"/>
                        <a:t>8.575 e-11 / 10.07</a:t>
                      </a:r>
                      <a:endParaRPr lang="en-US" sz="2400" b="1" dirty="0">
                        <a:solidFill>
                          <a:schemeClr val="tx1"/>
                        </a:solidFill>
                      </a:endParaRPr>
                    </a:p>
                  </a:txBody>
                  <a:tcPr marL="47478" marR="47478"/>
                </a:tc>
              </a:tr>
            </a:tbl>
          </a:graphicData>
        </a:graphic>
      </p:graphicFrame>
      <p:sp>
        <p:nvSpPr>
          <p:cNvPr id="6" name="Title 1"/>
          <p:cNvSpPr txBox="1">
            <a:spLocks/>
          </p:cNvSpPr>
          <p:nvPr/>
        </p:nvSpPr>
        <p:spPr>
          <a:xfrm>
            <a:off x="1187015" y="382691"/>
            <a:ext cx="9808503" cy="511174"/>
          </a:xfrm>
          <a:prstGeom prst="rect">
            <a:avLst/>
          </a:prstGeom>
        </p:spPr>
        <p:txBody>
          <a:bodyPr lIns="60417" tIns="30209" rIns="60417" bIns="30209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C50 of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ulvestrant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ZD9496 in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resenc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of increased doses of E2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926655" y="4231885"/>
            <a:ext cx="2774984" cy="430340"/>
          </a:xfrm>
          <a:prstGeom prst="rect">
            <a:avLst/>
          </a:prstGeom>
          <a:noFill/>
        </p:spPr>
        <p:txBody>
          <a:bodyPr wrap="none" lIns="60417" tIns="30209" rIns="60417" bIns="30209" rtlCol="0">
            <a:spAutoFit/>
          </a:bodyPr>
          <a:lstStyle/>
          <a:p>
            <a:r>
              <a:rPr lang="en-US" sz="2400" dirty="0"/>
              <a:t>pIC50= -Log10 ( IC50)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620558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ostina nardone</dc:creator>
  <cp:lastModifiedBy>agostina nardone</cp:lastModifiedBy>
  <cp:revision>1</cp:revision>
  <dcterms:created xsi:type="dcterms:W3CDTF">2018-04-22T23:07:50Z</dcterms:created>
  <dcterms:modified xsi:type="dcterms:W3CDTF">2018-04-22T23:09:44Z</dcterms:modified>
</cp:coreProperties>
</file>